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wmv" ContentType="video/x-ms-wmv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2" r:id="rId3"/>
    <p:sldId id="257" r:id="rId4"/>
    <p:sldId id="260" r:id="rId5"/>
    <p:sldId id="261" r:id="rId6"/>
    <p:sldId id="256" r:id="rId7"/>
    <p:sldId id="266" r:id="rId8"/>
    <p:sldId id="269" r:id="rId9"/>
    <p:sldId id="265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58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132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C085A8C3-8632-474F-AB78-35521B5C5ED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0972C187-3294-4C84-8B78-31A7AA21E0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D845DB3E-98AC-4A8E-891C-5DAB15080E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0A1A2-22B7-449A-B37C-A7398E7DC9DD}" type="datetimeFigureOut">
              <a:rPr lang="en-US" smtClean="0"/>
              <a:t>11/22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D4678CC3-BFCC-466F-ADA2-4B35B734FA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C8E32690-2BF1-4873-A563-A0EB8CE9CE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0A8D7-9B16-4A89-B240-0D4C32A3E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34171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CD39C517-5D59-4471-94D4-338F995620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6A5F5192-6582-4097-90FB-89B51C96FA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16D57BB8-5663-47B5-9767-0E6B1F4AC9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0A1A2-22B7-449A-B37C-A7398E7DC9DD}" type="datetimeFigureOut">
              <a:rPr lang="en-US" smtClean="0"/>
              <a:t>11/22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DCC62809-BC93-4C31-8833-28A631787A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E2CEF572-29F2-4DB0-98AE-AFAB7A2281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0A8D7-9B16-4A89-B240-0D4C32A3E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7083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638A9A47-BB58-4B25-B0A2-6186A38E63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B04D39C7-9854-41CB-AE6B-2CE58F16B7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658090D7-ABC0-46CE-A0C3-88143E1F9C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0A1A2-22B7-449A-B37C-A7398E7DC9DD}" type="datetimeFigureOut">
              <a:rPr lang="en-US" smtClean="0"/>
              <a:t>11/22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28836741-9B35-43AA-89FF-923B880A6A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2CAD61AB-BEF4-4F1F-B713-760C9E1415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0A8D7-9B16-4A89-B240-0D4C32A3E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6009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A8D4980-0342-42F4-B151-CEDC4419F8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4CB4EEBF-A685-48C8-9805-80F3F8A9246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9521DDF0-7E17-40C9-8766-EF325850C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0A1A2-22B7-449A-B37C-A7398E7DC9DD}" type="datetimeFigureOut">
              <a:rPr lang="en-US" smtClean="0"/>
              <a:t>11/22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8F3B5FF4-7A6C-48C0-9697-5D8335EBA4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79F52E25-0665-463A-BF4B-FC1E305A3E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0A8D7-9B16-4A89-B240-0D4C32A3E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8359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F6451C18-936E-4A47-8C32-4A94FA09EE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158DE542-EA0D-4CE8-AE16-17E821704A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A6540C43-21D6-4C57-9731-B4DA466E97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0A1A2-22B7-449A-B37C-A7398E7DC9DD}" type="datetimeFigureOut">
              <a:rPr lang="en-US" smtClean="0"/>
              <a:t>11/22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5AC769FD-CC80-443A-8314-0EF071A71E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6672F609-2B21-4EB1-9B4C-67A29FCC75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0A8D7-9B16-4A89-B240-0D4C32A3E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29100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8ECCA537-EC6D-4CA8-8D9D-63C8919545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41BB15C3-07D2-435E-B2F1-8EC8CEDC85D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FD45D12B-3594-4999-9A5C-30BD0F74BF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9A87FA91-A339-477E-A5DE-1D5E35001D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0A1A2-22B7-449A-B37C-A7398E7DC9DD}" type="datetimeFigureOut">
              <a:rPr lang="en-US" smtClean="0"/>
              <a:t>11/22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F407E708-0E06-4CC9-9578-92E104656B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831791F6-351C-4277-97D5-3AEC3268F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0A8D7-9B16-4A89-B240-0D4C32A3E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59833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DF25E13-87ED-4109-8982-A7B960C836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62B97FAE-8902-4C50-990E-C6957A272F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31BA71ED-1851-4CA8-8C2C-76A3065592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B6718B3A-24FA-417F-A67F-1D59B6E8CBB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B1379773-824B-440B-8D1F-3791DD54F67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5C063C6A-F33A-4986-A60D-97E7DB0F3D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0A1A2-22B7-449A-B37C-A7398E7DC9DD}" type="datetimeFigureOut">
              <a:rPr lang="en-US" smtClean="0"/>
              <a:t>11/22/20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56FC4234-8C3E-473E-B38C-389278B51A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CA51B41B-1DE0-47D0-9324-04C710CBEE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0A8D7-9B16-4A89-B240-0D4C32A3E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73713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9DF59C2-4FAE-4B9A-98FF-9FECA89E87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F527A88B-9D8E-4848-8A32-4777C471C2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0A1A2-22B7-449A-B37C-A7398E7DC9DD}" type="datetimeFigureOut">
              <a:rPr lang="en-US" smtClean="0"/>
              <a:t>11/22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2859FAC2-FB20-48E4-9390-82BD63953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019BE0E6-B4EB-41F7-AE6A-FCCEAE919C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0A8D7-9B16-4A89-B240-0D4C32A3E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90264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9C3D65F8-595E-4AF6-833B-92053C277C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0A1A2-22B7-449A-B37C-A7398E7DC9DD}" type="datetimeFigureOut">
              <a:rPr lang="en-US" smtClean="0"/>
              <a:t>11/22/20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FFD8D9F1-C48D-48E3-B9B1-91C6143F38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B6F517BF-B8D1-4D65-A0F4-F59629D7A4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0A8D7-9B16-4A89-B240-0D4C32A3E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7938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094F3D5-375A-4B85-BAF7-819CBC5B56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0F779898-1B3B-4297-B191-C654D85CF81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B9D0DB88-6A1B-4D35-9483-1F63363164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A6DF84CE-47A9-423F-885D-B351D33C35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0A1A2-22B7-449A-B37C-A7398E7DC9DD}" type="datetimeFigureOut">
              <a:rPr lang="en-US" smtClean="0"/>
              <a:t>11/22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298D6365-DA4A-47A2-96FA-C644C2B548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53AE4A74-7474-46E7-BDAA-5F63231801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0A8D7-9B16-4A89-B240-0D4C32A3E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7908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8CC4AA1-9B5D-4150-AA8D-13F160C767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E808866A-0C22-4EAD-89B5-9A2AEEA2840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1C88CEFF-F656-4159-B1A0-EC899936E0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43112E69-94C5-4EDE-BA01-009AA7E1A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0A1A2-22B7-449A-B37C-A7398E7DC9DD}" type="datetimeFigureOut">
              <a:rPr lang="en-US" smtClean="0"/>
              <a:t>11/22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FC0D556D-ECB3-464F-A059-0E5704C572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9085D11B-E39F-40FD-B9D4-935292CF3F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50A8D7-9B16-4A89-B240-0D4C32A3E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72575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B5E4F8B6-708D-4756-B482-65C45CD0E2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B8354993-3220-4446-98EA-9C02515A0A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35749C48-3E3F-4A7C-AF9D-86CAB8BBCB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A0A1A2-22B7-449A-B37C-A7398E7DC9DD}" type="datetimeFigureOut">
              <a:rPr lang="en-US" smtClean="0"/>
              <a:t>11/22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B6997A94-5F55-4A40-80A1-04889D4429E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B2B870D2-7922-434E-9257-CBE460FB2A2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50A8D7-9B16-4A89-B240-0D4C32A3E9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7363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hyperlink" Target="mailto:olga@evo.haifa.ac.il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.jpeg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wmv"/><Relationship Id="rId1" Type="http://schemas.microsoft.com/office/2007/relationships/media" Target="../media/media1.wmv"/><Relationship Id="rId5" Type="http://schemas.openxmlformats.org/officeDocument/2006/relationships/image" Target="../media/image5.png"/><Relationship Id="rId4" Type="http://schemas.openxmlformats.org/officeDocument/2006/relationships/image" Target="../media/image1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.jpeg"/><Relationship Id="rId4" Type="http://schemas.openxmlformats.org/officeDocument/2006/relationships/image" Target="../media/image8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2.wmv"/><Relationship Id="rId1" Type="http://schemas.microsoft.com/office/2007/relationships/media" Target="../media/media2.wmv"/><Relationship Id="rId5" Type="http://schemas.openxmlformats.org/officeDocument/2006/relationships/image" Target="../media/image1.jpeg"/><Relationship Id="rId4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microsoft.com/office/2007/relationships/media" Target="../media/media3.wmv"/><Relationship Id="rId1" Type="http://schemas.openxmlformats.org/officeDocument/2006/relationships/video" Target="NULL" TargetMode="External"/><Relationship Id="rId5" Type="http://schemas.openxmlformats.org/officeDocument/2006/relationships/image" Target="../media/image1.jpeg"/><Relationship Id="rId4" Type="http://schemas.openxmlformats.org/officeDocument/2006/relationships/image" Target="../media/image10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slideLayout" Target="../slideLayouts/slideLayout7.xml"/><Relationship Id="rId7" Type="http://schemas.microsoft.com/office/2007/relationships/hdphoto" Target="../media/hdphoto1.wdp"/><Relationship Id="rId2" Type="http://schemas.openxmlformats.org/officeDocument/2006/relationships/video" Target="../media/media4.wmv"/><Relationship Id="rId1" Type="http://schemas.microsoft.com/office/2007/relationships/media" Target="../media/media4.wmv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10" Type="http://schemas.openxmlformats.org/officeDocument/2006/relationships/image" Target="../media/image15.jpeg"/><Relationship Id="rId4" Type="http://schemas.openxmlformats.org/officeDocument/2006/relationships/image" Target="../media/image11.png"/><Relationship Id="rId9" Type="http://schemas.microsoft.com/office/2007/relationships/hdphoto" Target="../media/hdphoto2.wdp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jpeg"/></Relationships>
</file>

<file path=ppt/slides/_rels/slide9.xml.rels><?xml version="1.0" encoding="UTF-8" standalone="yes"?>
<Relationships xmlns="http://schemas.openxmlformats.org/package/2006/relationships"><Relationship Id="rId8" Type="http://schemas.microsoft.com/office/2007/relationships/hdphoto" Target="../media/hdphoto5.wdp"/><Relationship Id="rId3" Type="http://schemas.openxmlformats.org/officeDocument/2006/relationships/image" Target="../media/image19.png"/><Relationship Id="rId7" Type="http://schemas.openxmlformats.org/officeDocument/2006/relationships/image" Target="../media/image21.png"/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4.wdp"/><Relationship Id="rId5" Type="http://schemas.openxmlformats.org/officeDocument/2006/relationships/image" Target="../media/image20.png"/><Relationship Id="rId4" Type="http://schemas.microsoft.com/office/2007/relationships/hdphoto" Target="../media/hdphoto3.wdp"/><Relationship Id="rId9" Type="http://schemas.openxmlformats.org/officeDocument/2006/relationships/image" Target="../media/image2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569458" y="1393514"/>
            <a:ext cx="10736717" cy="32316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3174" bIns="0" numCol="1" anchor="ctr" anchorCtr="0" compatLnSpc="1">
            <a:prstTxWarp prst="textNoShape">
              <a:avLst/>
            </a:prstTxWarp>
            <a:spAutoFit/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petitive DNA in the architecture, </a:t>
            </a:r>
            <a:r>
              <a:rPr kumimoji="0" lang="en-US" alt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patterning</a:t>
            </a: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, and diversification of the genome of </a:t>
            </a:r>
            <a:r>
              <a:rPr kumimoji="0" lang="en-US" altLang="en-US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egilops speltoides</a:t>
            </a: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alt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ausch</a:t>
            </a: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kumimoji="0" lang="en-US" alt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oaceae</a:t>
            </a: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kumimoji="0" lang="en-US" altLang="en-US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riticeae</a:t>
            </a: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Yulia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Pollak</a:t>
            </a:r>
            <a:r>
              <a:rPr kumimoji="0" lang="en-US" altLang="en-US" sz="1200" b="1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US" altLang="en-US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kumimoji="0" lang="en-US" altLang="en-US" sz="1200" b="1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kumimoji="0" lang="en-US" alt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inat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Zelinger</a:t>
            </a:r>
            <a:r>
              <a:rPr kumimoji="0" lang="en-US" altLang="en-US" sz="1200" b="1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, Olga Raskina</a:t>
            </a:r>
            <a:r>
              <a:rPr kumimoji="0" lang="en-US" altLang="en-US" sz="1200" b="1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CSI center for scientific imaging, The Robert H. Smith Faculty of Agriculture, Food and Environment, The Hebrew University of Jerusalem, </a:t>
            </a:r>
            <a:r>
              <a:rPr kumimoji="0" lang="en-US" altLang="en-US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hovot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76100, Israel. </a:t>
            </a:r>
            <a:r>
              <a:rPr kumimoji="0" lang="en-US" altLang="en-US" sz="1200" b="1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Electron Microscopy Unit, Faculty of Natural Science, University of Haifa, Haifa, 3498838, Israel. </a:t>
            </a:r>
            <a:r>
              <a:rPr kumimoji="0" lang="en-US" altLang="en-US" sz="1200" b="1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stitute of Evolution, University of Haifa, Haifa 3498838, Israel.</a:t>
            </a:r>
            <a:r>
              <a:rPr kumimoji="0" lang="en-US" altLang="en-US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2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2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or correspondence: </a:t>
            </a:r>
            <a:endParaRPr kumimoji="0" lang="en-US" alt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-mail: </a:t>
            </a:r>
            <a:r>
              <a:rPr kumimoji="0" lang="en-US" altLang="en-US" sz="1200" b="0" i="0" u="sng" strike="noStrike" cap="none" normalizeH="0" baseline="0" dirty="0" smtClean="0">
                <a:ln>
                  <a:noFill/>
                </a:ln>
                <a:solidFill>
                  <a:srgbClr val="0000FF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hlinkClick r:id="rId2"/>
              </a:rPr>
              <a:t>olga@evo.haifa.ac.il</a:t>
            </a:r>
            <a:endParaRPr kumimoji="0" lang="en-US" altLang="en-US" sz="1200" b="0" i="0" u="sng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200" b="0" i="0" u="sng" strike="noStrike" cap="none" normalizeH="0" baseline="0" dirty="0" smtClean="0">
              <a:ln>
                <a:noFill/>
              </a:ln>
              <a:solidFill>
                <a:srgbClr val="0000FF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ype of article: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Original Article</a:t>
            </a:r>
          </a:p>
        </p:txBody>
      </p:sp>
      <p:pic>
        <p:nvPicPr>
          <p:cNvPr id="7" name="Picture 6" descr="C:\Users\Elaine.Scott\Documents\LaTex\____TEST____Frontiers_LaTeX_Templates_V2.5\Frontiers LaTeX (Science, Health and Engineering) V2.5 - with Supplementary material (V1.2)\logo1.jpg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22818" y="332740"/>
            <a:ext cx="1382395" cy="49657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6156542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lum bright="20000" contrast="40000"/>
          </a:blip>
          <a:stretch>
            <a:fillRect/>
          </a:stretch>
        </p:blipFill>
        <p:spPr>
          <a:xfrm>
            <a:off x="213934" y="1193355"/>
            <a:ext cx="3781678" cy="3029954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lum contrast="40000"/>
          </a:blip>
          <a:stretch>
            <a:fillRect/>
          </a:stretch>
        </p:blipFill>
        <p:spPr>
          <a:xfrm>
            <a:off x="4177759" y="1193355"/>
            <a:ext cx="3802460" cy="304660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lum bright="20000" contrast="40000"/>
          </a:blip>
          <a:stretch>
            <a:fillRect/>
          </a:stretch>
        </p:blipFill>
        <p:spPr>
          <a:xfrm>
            <a:off x="8162365" y="1193357"/>
            <a:ext cx="3802457" cy="304660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13934" y="4994500"/>
            <a:ext cx="117508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ed to Figure 2A4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vie S1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ree-dimensionally (3D) reconstructed confocal images of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o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phase nuclei from the anther somatic tissues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own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Figure 2A4.</a:t>
            </a:r>
            <a:endParaRPr lang="en-US" dirty="0"/>
          </a:p>
        </p:txBody>
      </p:sp>
      <p:pic>
        <p:nvPicPr>
          <p:cNvPr id="6" name="Picture 5" descr="C:\Users\Elaine.Scott\Documents\LaTex\____TEST____Frontiers_LaTeX_Templates_V2.5\Frontiers LaTeX (Science, Health and Engineering) V2.5 - with Supplementary material (V1.2)\logo1.jpg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0115" y="337112"/>
            <a:ext cx="1382395" cy="496570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TextBox 6"/>
          <p:cNvSpPr txBox="1"/>
          <p:nvPr/>
        </p:nvSpPr>
        <p:spPr>
          <a:xfrm>
            <a:off x="1038519" y="1219277"/>
            <a:ext cx="15279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uorescein-12-dUTP</a:t>
            </a:r>
            <a:endParaRPr lang="en-US" sz="12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814333" y="1216964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3</a:t>
            </a:r>
            <a:endParaRPr 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9616793" y="1193355"/>
            <a:ext cx="584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rge</a:t>
            </a:r>
            <a:endParaRPr lang="en-US" sz="12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60491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319259" y="5895892"/>
            <a:ext cx="781070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vie S1</a:t>
            </a:r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ed to Figur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A4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ree-dimensionally reconstructed confocal imag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wo interphase nuclei from the anther somatic tissues shown in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2A4.</a:t>
            </a:r>
          </a:p>
        </p:txBody>
      </p:sp>
      <p:pic>
        <p:nvPicPr>
          <p:cNvPr id="4" name="Picture 3" descr="C:\Users\Elaine.Scott\Documents\LaTex\____TEST____Frontiers_LaTeX_Templates_V2.5\Frontiers LaTeX (Science, Health and Engineering) V2.5 - with Supplementary material (V1.2)\logo1.jpg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5258" y="285115"/>
            <a:ext cx="1382395" cy="49657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2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>
            <a:lum bright="25000" contrast="55000"/>
          </a:blip>
          <a:stretch>
            <a:fillRect/>
          </a:stretch>
        </p:blipFill>
        <p:spPr>
          <a:xfrm>
            <a:off x="2319259" y="285115"/>
            <a:ext cx="7745272" cy="51515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870947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lum bright="20000" contrast="30000"/>
          </a:blip>
          <a:stretch>
            <a:fillRect/>
          </a:stretch>
        </p:blipFill>
        <p:spPr>
          <a:xfrm>
            <a:off x="383434" y="1201001"/>
            <a:ext cx="3631975" cy="2910009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63001" y="1201001"/>
            <a:ext cx="3631975" cy="291000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26434" y="1201001"/>
            <a:ext cx="3631975" cy="2910009"/>
          </a:xfrm>
          <a:prstGeom prst="rect">
            <a:avLst/>
          </a:prstGeom>
        </p:spPr>
      </p:pic>
      <p:pic>
        <p:nvPicPr>
          <p:cNvPr id="6" name="Picture 5" descr="C:\Users\Elaine.Scott\Documents\LaTex\____TEST____Frontiers_LaTeX_Templates_V2.5\Frontiers LaTeX (Science, Health and Engineering) V2.5 - with Supplementary material (V1.2)\logo1.jpg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434" y="240763"/>
            <a:ext cx="1382395" cy="496570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TextBox 6"/>
          <p:cNvSpPr txBox="1"/>
          <p:nvPr/>
        </p:nvSpPr>
        <p:spPr>
          <a:xfrm>
            <a:off x="383434" y="5074897"/>
            <a:ext cx="113749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ed to Figure 2A8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ovie S2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ree-dimensionally reconstructed c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focal images of the interphase nucleus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the anther somatic tissues shown in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2A8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38519" y="1219277"/>
            <a:ext cx="15279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uorescein-12-dUTP</a:t>
            </a:r>
            <a:endParaRPr lang="en-US" sz="12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806264" y="1219275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3</a:t>
            </a:r>
            <a:endParaRPr 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9446308" y="1201001"/>
            <a:ext cx="584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rge</a:t>
            </a:r>
            <a:endParaRPr lang="en-US" sz="12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16134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284-61 1 movie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>
            <a:lum bright="20000" contrast="40000"/>
          </a:blip>
          <a:srcRect l="18982" t="13535" r="25584" b="15319"/>
          <a:stretch/>
        </p:blipFill>
        <p:spPr>
          <a:xfrm>
            <a:off x="3707295" y="454659"/>
            <a:ext cx="4753389" cy="458825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314475" y="5710314"/>
            <a:ext cx="73562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vie S2</a:t>
            </a:r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ed to Figur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A8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Supplementary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ree-dimensionally reconstructed confocal imag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the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phas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cleus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the anther somatic tissues shown in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2A8.</a:t>
            </a:r>
          </a:p>
        </p:txBody>
      </p:sp>
      <p:pic>
        <p:nvPicPr>
          <p:cNvPr id="4" name="Picture 3" descr="C:\Users\Elaine.Scott\Documents\LaTex\____TEST____Frontiers_LaTeX_Templates_V2.5\Frontiers LaTeX (Science, Health and Engineering) V2.5 - with Supplementary material (V1.2)\logo1.jpg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352" y="206374"/>
            <a:ext cx="1382395" cy="49657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89958790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18.3.7 2nd slide 284-62 crop 2">
            <a:hlinkClick r:id="" action="ppaction://media"/>
            <a:extLst>
              <a:ext uri="{FF2B5EF4-FFF2-40B4-BE49-F238E27FC236}">
                <a16:creationId xmlns="" xmlns:a16="http://schemas.microsoft.com/office/drawing/2014/main" id="{A2B47BB8-CDA0-48CD-AD24-6F7E3FDD9CBF}"/>
              </a:ext>
            </a:extLst>
          </p:cNvPr>
          <p:cNvPicPr>
            <a:picLocks noChangeAspect="1"/>
          </p:cNvPicPr>
          <p:nvPr>
            <a:videoFile r:link="rId1"/>
            <p:extLst>
              <p:ext uri="{DAA4B4D4-6D71-4841-9C94-3DE7FCFB9230}">
                <p14:media xmlns:p14="http://schemas.microsoft.com/office/powerpoint/2010/main" r:embed="rId2">
                  <p14:trim st="724" end="390"/>
                </p14:media>
              </p:ext>
            </p:extLst>
          </p:nvPr>
        </p:nvPicPr>
        <p:blipFill rotWithShape="1">
          <a:blip r:embed="rId4"/>
          <a:srcRect l="12791" t="22662" r="14901" b="22496"/>
          <a:stretch/>
        </p:blipFill>
        <p:spPr>
          <a:xfrm>
            <a:off x="1630017" y="247015"/>
            <a:ext cx="9580285" cy="540509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572381" y="5999542"/>
            <a:ext cx="96955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vie S3</a:t>
            </a:r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ed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Figur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E and Supplementary Figur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ree-dimensionally reconstructed confocal imag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seven interphase nuclei of the somatic anther tissues.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ucleus shown in Figure 2E is indicated with yellow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row; 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o nucleoli ar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sible a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rk areas.</a:t>
            </a:r>
          </a:p>
        </p:txBody>
      </p:sp>
      <p:pic>
        <p:nvPicPr>
          <p:cNvPr id="4" name="Picture 3" descr="C:\Users\Elaine.Scott\Documents\LaTex\____TEST____Frontiers_LaTeX_Templates_V2.5\Frontiers LaTeX (Science, Health and Engineering) V2.5 - with Supplementary material (V1.2)\logo1.jpg"/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474" y="87989"/>
            <a:ext cx="1382395" cy="496570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5" name="Straight Arrow Connector 4"/>
          <p:cNvCxnSpPr/>
          <p:nvPr/>
        </p:nvCxnSpPr>
        <p:spPr>
          <a:xfrm flipH="1" flipV="1">
            <a:off x="8914917" y="1669000"/>
            <a:ext cx="586852" cy="3496"/>
          </a:xfrm>
          <a:prstGeom prst="straightConnector1">
            <a:avLst/>
          </a:prstGeom>
          <a:ln w="571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5981246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846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18.3.7 2nd slide 284-62 crop 5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>
            <a:lum bright="25000" contrast="49000"/>
          </a:blip>
          <a:stretch>
            <a:fillRect/>
          </a:stretch>
        </p:blipFill>
        <p:spPr>
          <a:xfrm>
            <a:off x="1182757" y="245097"/>
            <a:ext cx="7808266" cy="519348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02727" y="206514"/>
            <a:ext cx="2499525" cy="199962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19000" contrast="2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05759" y="2333618"/>
            <a:ext cx="2496493" cy="199719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8" cstate="print">
            <a:lum contrast="9000"/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3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23881" y="4458296"/>
            <a:ext cx="2478371" cy="1982697"/>
          </a:xfrm>
          <a:prstGeom prst="rect">
            <a:avLst/>
          </a:prstGeom>
        </p:spPr>
      </p:pic>
      <p:cxnSp>
        <p:nvCxnSpPr>
          <p:cNvPr id="7" name="Straight Arrow Connector 6"/>
          <p:cNvCxnSpPr/>
          <p:nvPr/>
        </p:nvCxnSpPr>
        <p:spPr>
          <a:xfrm flipH="1" flipV="1">
            <a:off x="6758126" y="1808148"/>
            <a:ext cx="586852" cy="3496"/>
          </a:xfrm>
          <a:prstGeom prst="straightConnector1">
            <a:avLst/>
          </a:prstGeom>
          <a:ln w="571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182757" y="5794662"/>
            <a:ext cx="78082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vie S4</a:t>
            </a:r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lated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Figur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E and Supplementary Figur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ree-dimensionally reconstructed confocal imag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seven interphase nuclei of the somatic anther tissues.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nucleus shown in Figure 2E is indicated with yellow arrow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In the </a:t>
            </a:r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ght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3D reconstructed confocal images of the nucleus taken from the movie.</a:t>
            </a:r>
          </a:p>
        </p:txBody>
      </p:sp>
      <p:cxnSp>
        <p:nvCxnSpPr>
          <p:cNvPr id="9" name="Straight Arrow Connector 8"/>
          <p:cNvCxnSpPr/>
          <p:nvPr/>
        </p:nvCxnSpPr>
        <p:spPr>
          <a:xfrm flipH="1" flipV="1">
            <a:off x="11112136" y="1092447"/>
            <a:ext cx="586852" cy="3496"/>
          </a:xfrm>
          <a:prstGeom prst="straightConnector1">
            <a:avLst/>
          </a:prstGeom>
          <a:ln w="571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Picture 10" descr="C:\Users\Elaine.Scott\Documents\LaTex\____TEST____Frontiers_LaTeX_Templates_V2.5\Frontiers LaTeX (Science, Health and Engineering) V2.5 - with Supplementary material (V1.2)\logo1.jpg"/>
          <p:cNvPicPr/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117807"/>
            <a:ext cx="1182757" cy="408967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34838591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lum bright="20000" contrast="30000"/>
          </a:blip>
          <a:stretch>
            <a:fillRect/>
          </a:stretch>
        </p:blipFill>
        <p:spPr>
          <a:xfrm>
            <a:off x="1109895" y="880626"/>
            <a:ext cx="4925551" cy="3946449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46540" y="1429018"/>
            <a:ext cx="5152542" cy="290235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109894" y="5137261"/>
            <a:ext cx="102891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ed to Figur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E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Supplementary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vies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S4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ru-RU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С</a:t>
            </a:r>
            <a:r>
              <a:rPr lang="en-US" alt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focal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-stack of seven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rphase nuclei of the somatic anther tissues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ree-dimensionally reconstructed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focal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age of the same nuclei obtained using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ageJ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ftware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us shown in Figur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E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 indicated with yellow arrow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dirty="0"/>
          </a:p>
        </p:txBody>
      </p:sp>
      <p:pic>
        <p:nvPicPr>
          <p:cNvPr id="6" name="Picture 5" descr="C:\Users\Elaine.Scott\Documents\LaTex\____TEST____Frontiers_LaTeX_Templates_V2.5\Frontiers LaTeX (Science, Health and Engineering) V2.5 - with Supplementary material (V1.2)\logo1.jpg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1302" y="199390"/>
            <a:ext cx="1382395" cy="496570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TextBox 6"/>
          <p:cNvSpPr txBox="1"/>
          <p:nvPr/>
        </p:nvSpPr>
        <p:spPr>
          <a:xfrm>
            <a:off x="1708620" y="967353"/>
            <a:ext cx="15279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rgbClr val="92D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uorescein-12-dUTP</a:t>
            </a:r>
          </a:p>
          <a:p>
            <a:r>
              <a:rPr lang="en-US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3</a:t>
            </a:r>
          </a:p>
          <a:p>
            <a:r>
              <a:rPr lang="en-US" sz="1200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en-US" sz="1200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Straight Arrow Connector 8"/>
          <p:cNvCxnSpPr/>
          <p:nvPr/>
        </p:nvCxnSpPr>
        <p:spPr>
          <a:xfrm flipH="1" flipV="1">
            <a:off x="10185238" y="2105981"/>
            <a:ext cx="586852" cy="3496"/>
          </a:xfrm>
          <a:prstGeom prst="straightConnector1">
            <a:avLst/>
          </a:prstGeom>
          <a:ln w="571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 flipH="1" flipV="1">
            <a:off x="4267589" y="2000653"/>
            <a:ext cx="586852" cy="3496"/>
          </a:xfrm>
          <a:prstGeom prst="straightConnector1">
            <a:avLst/>
          </a:prstGeom>
          <a:ln w="571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1113212" y="88062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12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246540" y="146469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1780984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1951" y="451948"/>
            <a:ext cx="10137148" cy="5638103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14000" contrast="1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2074" y="4073867"/>
            <a:ext cx="3241548" cy="1802892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13000" contrast="3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9240" y="4075001"/>
            <a:ext cx="2817876" cy="1802892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7" cstate="print">
            <a:lum contrast="8000"/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1000" contrast="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56347" y="4073867"/>
            <a:ext cx="2817876" cy="1802892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753996" y="6172940"/>
            <a:ext cx="103936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ed to Figure 2E and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vies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S4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deling of Spel1-Spelt52 clusters associations using IMARIS software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tplan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us shown in Figure 2E is indicated with yellow arrow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Straight Arrow Connector 7"/>
          <p:cNvCxnSpPr/>
          <p:nvPr/>
        </p:nvCxnSpPr>
        <p:spPr>
          <a:xfrm flipH="1" flipV="1">
            <a:off x="9923709" y="2508555"/>
            <a:ext cx="586852" cy="3496"/>
          </a:xfrm>
          <a:prstGeom prst="straightConnector1">
            <a:avLst/>
          </a:prstGeom>
          <a:ln w="571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 flipH="1" flipV="1">
            <a:off x="2299422" y="5276288"/>
            <a:ext cx="586852" cy="3496"/>
          </a:xfrm>
          <a:prstGeom prst="straightConnector1">
            <a:avLst/>
          </a:prstGeom>
          <a:ln w="571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/>
          <p:cNvCxnSpPr/>
          <p:nvPr/>
        </p:nvCxnSpPr>
        <p:spPr>
          <a:xfrm flipH="1" flipV="1">
            <a:off x="8756574" y="5428688"/>
            <a:ext cx="586852" cy="3496"/>
          </a:xfrm>
          <a:prstGeom prst="straightConnector1">
            <a:avLst/>
          </a:prstGeom>
          <a:ln w="57150">
            <a:solidFill>
              <a:srgbClr val="FFFF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Picture 11" descr="C:\Users\Elaine.Scott\Documents\LaTex\____TEST____Frontiers_LaTeX_Templates_V2.5\Frontiers LaTeX (Science, Health and Engineering) V2.5 - with Supplementary material (V1.2)\logo1.jpg"/>
          <p:cNvPicPr/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620" y="46118"/>
            <a:ext cx="1160753" cy="40583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7168788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51</TotalTime>
  <Words>438</Words>
  <Application>Microsoft Office PowerPoint</Application>
  <PresentationFormat>Widescreen</PresentationFormat>
  <Paragraphs>36</Paragraphs>
  <Slides>9</Slides>
  <Notes>0</Notes>
  <HiddenSlides>0</HiddenSlides>
  <MMClips>4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אולגה רסקין</dc:creator>
  <cp:lastModifiedBy>user</cp:lastModifiedBy>
  <cp:revision>140</cp:revision>
  <dcterms:created xsi:type="dcterms:W3CDTF">2018-10-13T12:26:28Z</dcterms:created>
  <dcterms:modified xsi:type="dcterms:W3CDTF">2018-11-22T15:16:42Z</dcterms:modified>
</cp:coreProperties>
</file>